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01647-E171-4C0C-920C-5FB8D7C2CD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EF6B5-D688-4D29-82C9-E3E0444130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DA5E4-EDFA-4454-BBD4-9CDEEACDF3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1B59E-E1E6-4069-B8BB-E46E494AED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AB2F6-578F-49EF-928B-195CFB8680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AAAC4-0667-4238-BE60-AFD1FA6746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BA1563-1935-40EC-A4A9-EAB7DD161F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76795-6DAA-41EB-87F5-2316156A97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54E21-09BB-4141-9E9B-3A767B18EA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6A013-B090-4106-BAD8-75CBD88C07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D67EE-E630-4254-A7EA-74CBEA6CA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E250A-43B6-429E-9CC6-EF3FFA6E66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2FF366-4CDD-4158-BD30-A183982777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5"/>
          <p:cNvGrpSpPr/>
          <p:nvPr/>
        </p:nvGrpSpPr>
        <p:grpSpPr>
          <a:xfrm>
            <a:off x="2419200" y="1125720"/>
            <a:ext cx="1595520" cy="2008080"/>
            <a:chOff x="2419200" y="1125720"/>
            <a:chExt cx="1595520" cy="2008080"/>
          </a:xfrm>
        </p:grpSpPr>
        <p:pic>
          <p:nvPicPr>
            <p:cNvPr id="42" name="Picture 2" descr="Screen Shot 2011-08-02 at 3.34.28 PM 2.png"/>
            <p:cNvPicPr/>
            <p:nvPr/>
          </p:nvPicPr>
          <p:blipFill>
            <a:blip r:embed="rId1"/>
            <a:srcRect l="-294" t="0" r="3749" b="82477"/>
            <a:stretch/>
          </p:blipFill>
          <p:spPr>
            <a:xfrm>
              <a:off x="2419200" y="1895760"/>
              <a:ext cx="838440" cy="29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25"/>
            <p:cNvSpPr/>
            <p:nvPr/>
          </p:nvSpPr>
          <p:spPr>
            <a:xfrm>
              <a:off x="3335760" y="1935360"/>
              <a:ext cx="67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urviv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26"/>
            <p:cNvSpPr/>
            <p:nvPr/>
          </p:nvSpPr>
          <p:spPr>
            <a:xfrm flipH="1">
              <a:off x="3281400" y="3016440"/>
              <a:ext cx="123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27"/>
            <p:cNvSpPr/>
            <p:nvPr/>
          </p:nvSpPr>
          <p:spPr>
            <a:xfrm flipH="1">
              <a:off x="3281400" y="2057760"/>
              <a:ext cx="123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38"/>
            <p:cNvSpPr/>
            <p:nvPr/>
          </p:nvSpPr>
          <p:spPr>
            <a:xfrm>
              <a:off x="3335400" y="288468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25"/>
            <p:cNvSpPr/>
            <p:nvPr/>
          </p:nvSpPr>
          <p:spPr>
            <a:xfrm>
              <a:off x="3335760" y="224028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cl-x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27"/>
            <p:cNvSpPr/>
            <p:nvPr/>
          </p:nvSpPr>
          <p:spPr>
            <a:xfrm flipH="1">
              <a:off x="3281400" y="2362320"/>
              <a:ext cx="123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62"/>
            <p:cNvSpPr/>
            <p:nvPr/>
          </p:nvSpPr>
          <p:spPr>
            <a:xfrm flipH="1">
              <a:off x="3281400" y="2703960"/>
              <a:ext cx="123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25"/>
            <p:cNvSpPr/>
            <p:nvPr/>
          </p:nvSpPr>
          <p:spPr>
            <a:xfrm>
              <a:off x="3336120" y="258300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cl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5"/>
            <p:cNvSpPr/>
            <p:nvPr/>
          </p:nvSpPr>
          <p:spPr>
            <a:xfrm rot="18600000">
              <a:off x="2463480" y="1572840"/>
              <a:ext cx="5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T4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5"/>
            <p:cNvSpPr/>
            <p:nvPr/>
          </p:nvSpPr>
          <p:spPr>
            <a:xfrm rot="18600000">
              <a:off x="2812320" y="1436040"/>
              <a:ext cx="92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T474-HR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2" descr="Screen Shot 2011-08-02 at 3.34.28 PM 2.png"/>
            <p:cNvPicPr/>
            <p:nvPr/>
          </p:nvPicPr>
          <p:blipFill>
            <a:blip r:embed="rId2"/>
            <a:srcRect l="2494" t="43369" r="1875" b="40644"/>
            <a:stretch/>
          </p:blipFill>
          <p:spPr>
            <a:xfrm>
              <a:off x="2419200" y="2219760"/>
              <a:ext cx="839880" cy="29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2" descr="Screen Shot 2011-08-02 at 3.34.28 PM 2.png"/>
            <p:cNvPicPr/>
            <p:nvPr/>
          </p:nvPicPr>
          <p:blipFill>
            <a:blip r:embed="rId3"/>
            <a:srcRect l="3935" t="85202" r="0" b="0"/>
            <a:stretch/>
          </p:blipFill>
          <p:spPr>
            <a:xfrm>
              <a:off x="2419200" y="2857680"/>
              <a:ext cx="838440" cy="27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2" descr="Screen Shot 2011-08-02 at 3.34.28 PM 2.png"/>
            <p:cNvPicPr/>
            <p:nvPr/>
          </p:nvPicPr>
          <p:blipFill>
            <a:blip r:embed="rId4"/>
            <a:srcRect l="1565" t="64149" r="930" b="20715"/>
            <a:stretch/>
          </p:blipFill>
          <p:spPr>
            <a:xfrm>
              <a:off x="2419200" y="2543400"/>
              <a:ext cx="838440" cy="282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6" name="Group 24"/>
          <p:cNvGrpSpPr/>
          <p:nvPr/>
        </p:nvGrpSpPr>
        <p:grpSpPr>
          <a:xfrm>
            <a:off x="1828800" y="3600360"/>
            <a:ext cx="2562120" cy="2376720"/>
            <a:chOff x="1828800" y="3600360"/>
            <a:chExt cx="2562120" cy="2376720"/>
          </a:xfrm>
        </p:grpSpPr>
        <p:pic>
          <p:nvPicPr>
            <p:cNvPr id="57" name="Chart 29" descr=""/>
            <p:cNvPicPr/>
            <p:nvPr/>
          </p:nvPicPr>
          <p:blipFill>
            <a:blip r:embed="rId5"/>
            <a:stretch/>
          </p:blipFill>
          <p:spPr>
            <a:xfrm>
              <a:off x="2054160" y="3600360"/>
              <a:ext cx="2249640" cy="208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 Box 3"/>
            <p:cNvSpPr/>
            <p:nvPr/>
          </p:nvSpPr>
          <p:spPr>
            <a:xfrm rot="16200000">
              <a:off x="1166040" y="4542480"/>
              <a:ext cx="1586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urvival (% Control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9"/>
            <p:cNvSpPr/>
            <p:nvPr/>
          </p:nvSpPr>
          <p:spPr>
            <a:xfrm>
              <a:off x="2576520" y="4964040"/>
              <a:ext cx="741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&lt;0.0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2"/>
            <p:cNvSpPr/>
            <p:nvPr/>
          </p:nvSpPr>
          <p:spPr>
            <a:xfrm>
              <a:off x="2247840" y="5535000"/>
              <a:ext cx="21430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    2       4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    8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 16     3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3"/>
            <p:cNvSpPr/>
            <p:nvPr/>
          </p:nvSpPr>
          <p:spPr>
            <a:xfrm>
              <a:off x="2581200" y="5715720"/>
              <a:ext cx="1447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aclitaxel (nmol/L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8"/>
            <p:cNvSpPr/>
            <p:nvPr/>
          </p:nvSpPr>
          <p:spPr>
            <a:xfrm>
              <a:off x="3343320" y="4926240"/>
              <a:ext cx="25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0"/>
            <p:cNvSpPr/>
            <p:nvPr/>
          </p:nvSpPr>
          <p:spPr>
            <a:xfrm>
              <a:off x="2997720" y="45154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8"/>
            <p:cNvSpPr/>
            <p:nvPr/>
          </p:nvSpPr>
          <p:spPr>
            <a:xfrm>
              <a:off x="4052880" y="5249520"/>
              <a:ext cx="25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0"/>
            <p:cNvSpPr/>
            <p:nvPr/>
          </p:nvSpPr>
          <p:spPr>
            <a:xfrm>
              <a:off x="3697920" y="5114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TextBox 48"/>
          <p:cNvSpPr/>
          <p:nvPr/>
        </p:nvSpPr>
        <p:spPr>
          <a:xfrm>
            <a:off x="1916280" y="1171440"/>
            <a:ext cx="29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9"/>
          <p:cNvSpPr/>
          <p:nvPr/>
        </p:nvSpPr>
        <p:spPr>
          <a:xfrm>
            <a:off x="1702440" y="3440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4"/>
          <p:cNvSpPr/>
          <p:nvPr/>
        </p:nvSpPr>
        <p:spPr>
          <a:xfrm>
            <a:off x="2333160" y="8255160"/>
            <a:ext cx="172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ang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.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3T17:46:49Z</dcterms:created>
  <dc:creator>Liu, Bolin</dc:creator>
  <dc:description/>
  <dc:language>en-US</dc:language>
  <cp:lastModifiedBy>Liu, Bolin</cp:lastModifiedBy>
  <dcterms:modified xsi:type="dcterms:W3CDTF">2013-08-30T16:10:14Z</dcterms:modified>
  <cp:revision>194</cp:revision>
  <dc:subject/>
  <dc:title>Slide 1</dc:title>
</cp:coreProperties>
</file>